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6" d="100"/>
          <a:sy n="106" d="100"/>
        </p:scale>
        <p:origin x="75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F851800-8C4F-45B6-81A8-611ECA3D504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82BF0781-003E-4613-9C44-02ED0DCEFBE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7E8EF4F-D15A-4ED2-AA93-B2E3D2E263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7636E-7DBF-42A3-B987-0B4B5CEF82B5}" type="datetimeFigureOut">
              <a:rPr lang="de-DE" smtClean="0"/>
              <a:t>12.06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86A8A93-6839-4B4C-B5E5-1D505C669B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F6900B3-88C3-4BA5-B8F4-1CA68ED895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11D795-70EF-41A1-8DF1-FAA9EB720B8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813284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16C6A75-853F-46EC-843A-99050B5144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2FB56C3C-FBB8-4D41-8B9E-59CD27CDC7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3968BF5-7544-41CB-8D74-0E7B87F396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7636E-7DBF-42A3-B987-0B4B5CEF82B5}" type="datetimeFigureOut">
              <a:rPr lang="de-DE" smtClean="0"/>
              <a:t>12.06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156F9CE-4F5E-4AE3-8530-857093747D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0D95900-8D7A-4BB3-B51C-68AA607519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11D795-70EF-41A1-8DF1-FAA9EB720B8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725065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FDA84E3E-5FC4-4367-9B97-534313D272D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4694A80E-0644-490B-8940-42199FD047F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E797833-6813-48D3-B12F-2D88058899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7636E-7DBF-42A3-B987-0B4B5CEF82B5}" type="datetimeFigureOut">
              <a:rPr lang="de-DE" smtClean="0"/>
              <a:t>12.06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CD1D527-275B-4BF1-9B78-B29488653F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06D6F6E-E72D-4F56-806D-5D1D9E66E6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11D795-70EF-41A1-8DF1-FAA9EB720B8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20539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93E64EA-1FEE-4B3E-9B49-0C860F228C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53393FAD-94FC-4D16-B5EE-9F7CF71F4E6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F64D10D-CB0A-4C83-A904-EC4E1A0944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7636E-7DBF-42A3-B987-0B4B5CEF82B5}" type="datetimeFigureOut">
              <a:rPr lang="de-DE" smtClean="0"/>
              <a:t>12.06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3EC5157-6CA7-4540-A690-738163A1CF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9E3600F-C99E-4477-B65E-BC17C8B8F4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11D795-70EF-41A1-8DF1-FAA9EB720B8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491845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8D2618B-B4E9-4F5B-A1A8-0DA5280E20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8946806-B2CD-42E5-A3E2-338DA3478F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AEA5E7E-2AF0-408D-B279-4269F5EEF9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7636E-7DBF-42A3-B987-0B4B5CEF82B5}" type="datetimeFigureOut">
              <a:rPr lang="de-DE" smtClean="0"/>
              <a:t>12.06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AE07B8E-FD8B-4181-9B86-CCD257528E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BDD037B-CD7D-499C-92D1-52678E331D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11D795-70EF-41A1-8DF1-FAA9EB720B8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911563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D29C940-C72B-4FAD-BB75-60DD481A0E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C3E6B564-CC33-428F-B18C-AE1F6D3AC32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BDCED1C8-A425-4F2D-9D17-5B5076CADA5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9F0FBA87-B53D-44B4-986C-E217E0AA4C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7636E-7DBF-42A3-B987-0B4B5CEF82B5}" type="datetimeFigureOut">
              <a:rPr lang="de-DE" smtClean="0"/>
              <a:t>12.06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B4E58622-4B96-45EE-A592-4AE6747B3D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4869BC53-23C2-4496-B433-D751036293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11D795-70EF-41A1-8DF1-FAA9EB720B8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005039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7552ABE-4283-4F4F-857A-FB7994A80F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67BCE681-F42F-48FE-9479-5B674ABA03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2D9DE178-41AF-431C-A4DE-AEB8D69371E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03DBF7E2-14FD-4F9B-A851-6921716D294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34ECB451-8F1E-4B14-80B2-8E132C6D6CB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9FEAAFB1-3298-4DE5-85D5-AA57830792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7636E-7DBF-42A3-B987-0B4B5CEF82B5}" type="datetimeFigureOut">
              <a:rPr lang="de-DE" smtClean="0"/>
              <a:t>12.06.2025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E230FAD0-4433-4E10-AFF6-723EF0D7FA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5783BF10-11B8-4B1D-9888-7907635E05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11D795-70EF-41A1-8DF1-FAA9EB720B8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326697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7D9850F-E714-4E62-8052-626F86E775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F7BBC690-F2AB-46B2-9B22-C7B665095D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7636E-7DBF-42A3-B987-0B4B5CEF82B5}" type="datetimeFigureOut">
              <a:rPr lang="de-DE" smtClean="0"/>
              <a:t>12.06.2025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F869F87E-D874-42F2-B436-9F3C34CAE0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3E5DFF2C-4051-41BA-BB11-04152FB34D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11D795-70EF-41A1-8DF1-FAA9EB720B8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015628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A0E311C8-D6B6-434C-8295-2CBDEB83ED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7636E-7DBF-42A3-B987-0B4B5CEF82B5}" type="datetimeFigureOut">
              <a:rPr lang="de-DE" smtClean="0"/>
              <a:t>12.06.2025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7E637110-D444-4B85-97BE-EE00908883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76F614AB-D8E2-4BC4-9A13-433217CD41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11D795-70EF-41A1-8DF1-FAA9EB720B8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21951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4F435B2-9F9D-4271-B4C6-65603744FC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9BA03916-46C8-4A7A-B419-FD575B12E75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F6D0E113-F6E1-4565-96EC-2AEC2CE2697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E3B07F1D-A881-45B7-BF5D-6E3AE51F94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7636E-7DBF-42A3-B987-0B4B5CEF82B5}" type="datetimeFigureOut">
              <a:rPr lang="de-DE" smtClean="0"/>
              <a:t>12.06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1B430D86-C3E5-40C3-8DBF-8EEF54C72E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1430492C-274E-43B7-B42A-5E60411DFE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11D795-70EF-41A1-8DF1-FAA9EB720B8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226544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AF55BCE-B9D9-4AE0-8A5C-C81560A34F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48ED21E9-AF3A-4860-84FD-DA68254D72E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C340F66A-117D-45DA-9A3D-CFAEF51882B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78600B04-3A70-4934-A01B-73C45649D5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7636E-7DBF-42A3-B987-0B4B5CEF82B5}" type="datetimeFigureOut">
              <a:rPr lang="de-DE" smtClean="0"/>
              <a:t>12.06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852B7A8E-9550-499E-86E9-36C14B5509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9B7113F4-D75C-4A79-893A-24FA52C9BB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11D795-70EF-41A1-8DF1-FAA9EB720B8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662403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49D8E4ED-DF71-4391-AB06-1986E8D775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D2940755-894D-4848-A224-18AEA61305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0E119E6-A0E6-4BCB-BF7A-CF2DA32A0C5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A7636E-7DBF-42A3-B987-0B4B5CEF82B5}" type="datetimeFigureOut">
              <a:rPr lang="de-DE" smtClean="0"/>
              <a:t>12.06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664E7AB-D3FC-4F02-90B3-D6943E14912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530933E-467A-4AEB-B0AC-A861F706A0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11D795-70EF-41A1-8DF1-FAA9EB720B8D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010358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hteck 9">
            <a:extLst>
              <a:ext uri="{FF2B5EF4-FFF2-40B4-BE49-F238E27FC236}">
                <a16:creationId xmlns:a16="http://schemas.microsoft.com/office/drawing/2014/main" id="{FC949820-93BD-4FBC-980B-6D8237DBDDCF}"/>
              </a:ext>
            </a:extLst>
          </p:cNvPr>
          <p:cNvSpPr/>
          <p:nvPr/>
        </p:nvSpPr>
        <p:spPr>
          <a:xfrm>
            <a:off x="585926" y="372862"/>
            <a:ext cx="3116062" cy="3409025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pic>
        <p:nvPicPr>
          <p:cNvPr id="6" name="Bildplatzhalter 5">
            <a:extLst>
              <a:ext uri="{FF2B5EF4-FFF2-40B4-BE49-F238E27FC236}">
                <a16:creationId xmlns:a16="http://schemas.microsoft.com/office/drawing/2014/main" id="{9519C960-7231-4EC9-B48C-BC331092C97B}"/>
              </a:ext>
            </a:extLst>
          </p:cNvPr>
          <p:cNvPicPr>
            <a:picLocks noGrp="1" noChangeAspect="1"/>
          </p:cNvPicPr>
          <p:nvPr>
            <p:ph type="pic"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74" t="15640" r="78921" b="53818"/>
          <a:stretch/>
        </p:blipFill>
        <p:spPr>
          <a:xfrm>
            <a:off x="2212020" y="522673"/>
            <a:ext cx="1349406" cy="1488490"/>
          </a:xfrm>
        </p:spPr>
      </p:pic>
      <p:pic>
        <p:nvPicPr>
          <p:cNvPr id="8" name="Bildplatzhalter 5">
            <a:extLst>
              <a:ext uri="{FF2B5EF4-FFF2-40B4-BE49-F238E27FC236}">
                <a16:creationId xmlns:a16="http://schemas.microsoft.com/office/drawing/2014/main" id="{C44E682F-3433-4BBE-8EA6-C74370C06AB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839" t="14244" r="53855" b="55109"/>
          <a:stretch/>
        </p:blipFill>
        <p:spPr>
          <a:xfrm>
            <a:off x="746184" y="534820"/>
            <a:ext cx="1349407" cy="1493669"/>
          </a:xfrm>
          <a:prstGeom prst="rect">
            <a:avLst/>
          </a:prstGeom>
        </p:spPr>
      </p:pic>
      <p:sp>
        <p:nvSpPr>
          <p:cNvPr id="11" name="Textfeld 10">
            <a:extLst>
              <a:ext uri="{FF2B5EF4-FFF2-40B4-BE49-F238E27FC236}">
                <a16:creationId xmlns:a16="http://schemas.microsoft.com/office/drawing/2014/main" id="{E9BE7CEE-FE7E-416F-BC75-EB859C4F18DD}"/>
              </a:ext>
            </a:extLst>
          </p:cNvPr>
          <p:cNvSpPr txBox="1"/>
          <p:nvPr/>
        </p:nvSpPr>
        <p:spPr>
          <a:xfrm>
            <a:off x="702814" y="45452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solidFill>
                  <a:schemeClr val="bg1"/>
                </a:solidFill>
              </a:rPr>
              <a:t>A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5382C348-5F32-49A8-B849-06DE39C788B2}"/>
              </a:ext>
            </a:extLst>
          </p:cNvPr>
          <p:cNvSpPr txBox="1"/>
          <p:nvPr/>
        </p:nvSpPr>
        <p:spPr>
          <a:xfrm>
            <a:off x="2176109" y="454523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solidFill>
                  <a:schemeClr val="bg1"/>
                </a:solidFill>
              </a:rPr>
              <a:t>B</a:t>
            </a:r>
          </a:p>
        </p:txBody>
      </p:sp>
      <p:pic>
        <p:nvPicPr>
          <p:cNvPr id="16" name="Bildplatzhalter 5">
            <a:extLst>
              <a:ext uri="{FF2B5EF4-FFF2-40B4-BE49-F238E27FC236}">
                <a16:creationId xmlns:a16="http://schemas.microsoft.com/office/drawing/2014/main" id="{A268F907-1C26-49A4-997A-12D54AB2276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489" t="21948" r="34064" b="18070"/>
          <a:stretch/>
        </p:blipFill>
        <p:spPr>
          <a:xfrm>
            <a:off x="1486583" y="2125460"/>
            <a:ext cx="1292802" cy="1493671"/>
          </a:xfrm>
          <a:prstGeom prst="rect">
            <a:avLst/>
          </a:prstGeom>
        </p:spPr>
      </p:pic>
      <p:sp>
        <p:nvSpPr>
          <p:cNvPr id="13" name="Textfeld 12">
            <a:extLst>
              <a:ext uri="{FF2B5EF4-FFF2-40B4-BE49-F238E27FC236}">
                <a16:creationId xmlns:a16="http://schemas.microsoft.com/office/drawing/2014/main" id="{77FE36DF-44DA-4301-8ACB-81A2F5F51C93}"/>
              </a:ext>
            </a:extLst>
          </p:cNvPr>
          <p:cNvSpPr txBox="1"/>
          <p:nvPr/>
        </p:nvSpPr>
        <p:spPr>
          <a:xfrm>
            <a:off x="1429765" y="2046245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solidFill>
                  <a:schemeClr val="bg1"/>
                </a:solidFill>
              </a:rPr>
              <a:t>C</a:t>
            </a:r>
          </a:p>
        </p:txBody>
      </p:sp>
      <p:sp>
        <p:nvSpPr>
          <p:cNvPr id="2" name="Textfeld 1">
            <a:extLst>
              <a:ext uri="{FF2B5EF4-FFF2-40B4-BE49-F238E27FC236}">
                <a16:creationId xmlns:a16="http://schemas.microsoft.com/office/drawing/2014/main" id="{5DEDCA63-1114-40C1-BED7-423A98A47350}"/>
              </a:ext>
            </a:extLst>
          </p:cNvPr>
          <p:cNvSpPr txBox="1"/>
          <p:nvPr/>
        </p:nvSpPr>
        <p:spPr>
          <a:xfrm>
            <a:off x="3862246" y="376269"/>
            <a:ext cx="3096091" cy="24082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GB" sz="1200" b="1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</a:t>
            </a:r>
            <a:r>
              <a:rPr lang="en-GB" sz="1200" b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2</a:t>
            </a:r>
            <a:r>
              <a:rPr lang="en-GB" sz="1200" b="1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Initial MRI at diagnosis (case report). </a:t>
            </a:r>
            <a:endParaRPr lang="en-GB" sz="1200" b="1" dirty="0">
              <a:latin typeface="Palatino Linotype" panose="0204050205050503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GB" sz="12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itial MRI shows a cavernoma with evidence of </a:t>
            </a:r>
            <a:r>
              <a:rPr lang="en-GB" sz="1200" dirty="0" err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emorrhage</a:t>
            </a:r>
            <a:r>
              <a:rPr lang="en-GB" sz="12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the left thalamus in the T2* weighted sequence (</a:t>
            </a:r>
            <a:r>
              <a:rPr lang="en-GB" sz="1200" b="1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2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</a:t>
            </a:r>
            <a:r>
              <a:rPr lang="en-GB" sz="1200" dirty="0" err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dema</a:t>
            </a:r>
            <a:r>
              <a:rPr lang="en-GB" sz="12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 the left dorsal internal capsula in the T2 weighted sequence in axial and </a:t>
            </a:r>
            <a:r>
              <a:rPr lang="en-GB" sz="1200" dirty="0" err="1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ronar</a:t>
            </a:r>
            <a:r>
              <a:rPr lang="en-GB" sz="12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lanes (</a:t>
            </a:r>
            <a:r>
              <a:rPr lang="en-GB" sz="1200" b="1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sz="1200" b="1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GB" sz="1200" b="1" dirty="0"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2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</a:t>
            </a:r>
            <a:endParaRPr lang="de-DE" sz="1200" dirty="0">
              <a:effectLst/>
              <a:latin typeface="Palatino Linotype" panose="0204050205050503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020917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0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horsteinsdottir, Jun  Dr.med.</dc:creator>
  <cp:lastModifiedBy>MDPI</cp:lastModifiedBy>
  <cp:revision>13</cp:revision>
  <dcterms:created xsi:type="dcterms:W3CDTF">2024-08-13T12:07:35Z</dcterms:created>
  <dcterms:modified xsi:type="dcterms:W3CDTF">2025-06-12T10:10:57Z</dcterms:modified>
</cp:coreProperties>
</file>